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73" d="100"/>
          <a:sy n="73" d="100"/>
        </p:scale>
        <p:origin x="6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D2D306-7283-467C-A9C9-788A2F21DE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CBB8C1-BFCD-4546-BB74-96E0EA8147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0A63E-819B-4F41-A7C4-D8DAF87AD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368F3-A28A-4AB5-8B8D-5AB4707D7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51F3E2-D3EE-4B16-B333-376C69E5F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852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E6839-B9EB-494B-9E7C-B2BD89B151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52BC05-A26C-4802-931C-7BD1115AEF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8CF928-605B-417E-84EA-AF31DB8FC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C10192-7F24-4343-8F95-3092EB5E7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245399-3521-4AF5-B5CE-DE8564205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567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9E92B8-65BB-4053-BAC3-660FD266B3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AC7190-322E-49BD-8071-A0655BFDFE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0A7E52-5CE1-4C99-B80B-3F4F8B5A2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5C8C3D-FB40-433C-910C-9060C6F1C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916199-6458-4273-9C13-CA9871A80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733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080C3-5974-4DD5-BABC-B6A75AB6D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7CE9F1-EA08-46F5-9195-8043618BE5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E5D537-3649-4400-A7B9-31934E92A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EF6C5D-909C-42F2-BD84-031EBB382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8B7A34-7460-4E0F-AFD4-A165F9068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894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689642-CEF4-4F5E-BD34-E33C57819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D29C20-0CFB-436F-9174-B9AF20B122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9F2D1-3ED6-47D6-8D2E-CDDE9CE66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D39A67-0744-4D09-BE3C-9D872512F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16926-6802-40AA-8BA3-23EB45A02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920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038D04-2301-404C-9BC1-CE2A60ED4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4CFC24-87A0-4BBE-A4BE-2984C72842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18F701-A261-4304-899F-B2C7630141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C15D0F-A714-42B9-AC1E-4B6AB2F48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539F18-C65B-4D3F-B01F-8DD9E0352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B025B1-7E58-49E7-B930-04D5E01FA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108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94567D-DAC3-4E4C-869E-14AC06107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6A55C1-0667-4CBD-A274-2FEC6EA910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5057F2-8EBE-4C43-AE48-F75D1AE75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1F8BF0-51D7-4976-A3B9-A028E9FC34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C91855-DB61-4B71-A3FC-3FE028F3C4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FCF774-8C51-4E6F-AD55-01E96592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A9CBB8-C752-4738-B43E-AFBC716EB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BC74715-9679-48AD-B39C-5DA39AF26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215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037AC-9D80-40D6-9DDD-8108B9C73E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C44AEA-FC7D-43C1-AFBF-E8608DFEB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96E510-19D8-46DD-AD8B-15EDE1A85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C251AC-71CA-4BEC-ABC9-6A8A342CD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963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8EB2F8-B58B-48AC-89A7-4F1B91C8D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AC3B56-0833-4FE5-9D23-4FFD63BE1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90FFBA-B917-40DF-BA6E-9B31B3213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669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C47467-1698-4DE3-AA40-054F8DEF4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8B11CA-134E-424A-91D8-E212E594D3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B808DC-90C4-41FA-ABC6-38E952E982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38C090-38A1-42FD-B7F5-AEF6980DA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ED717B-1339-4691-970C-E7B95410C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0B9BDD-FFE1-4811-81DC-7CA122B90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076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3E84F-5032-414B-AFF6-42DDEA912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C1589D-8BEA-4AA3-8EB4-DC1978A08D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4D00DE-4390-4585-B107-24E7E2D190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23D47C-99A8-409A-8110-79FA9D983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485691-9F75-4594-BBD4-1EAE9B78A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183E58-6A93-45E7-A332-C2C2EA97E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922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106F12-A62A-468A-9535-FC438A8557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F726BE-D251-4F81-A8E9-7EC2EDB31E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CCEBC-496B-4A36-AB87-E976E5A369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5076F-1E60-4FFD-80DD-692BBB64516D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361F97-C663-4C12-8670-78FBA6D252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FB4A18-A2F0-4BAA-9E10-23C959DE64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46C98-A6F6-4EC5-93BA-2F75D3238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203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4916086" y="516741"/>
            <a:ext cx="2260974" cy="969725"/>
            <a:chOff x="1850382" y="702092"/>
            <a:chExt cx="2110128" cy="969725"/>
          </a:xfrm>
        </p:grpSpPr>
        <p:grpSp>
          <p:nvGrpSpPr>
            <p:cNvPr id="70" name="Group 69"/>
            <p:cNvGrpSpPr/>
            <p:nvPr/>
          </p:nvGrpSpPr>
          <p:grpSpPr>
            <a:xfrm>
              <a:off x="1850382" y="1040282"/>
              <a:ext cx="2110128" cy="631535"/>
              <a:chOff x="5230893" y="580087"/>
              <a:chExt cx="2110128" cy="631535"/>
            </a:xfrm>
          </p:grpSpPr>
          <p:grpSp>
            <p:nvGrpSpPr>
              <p:cNvPr id="71" name="Group 70"/>
              <p:cNvGrpSpPr/>
              <p:nvPr/>
            </p:nvGrpSpPr>
            <p:grpSpPr>
              <a:xfrm>
                <a:off x="5230893" y="580087"/>
                <a:ext cx="2110128" cy="290853"/>
                <a:chOff x="5230893" y="580087"/>
                <a:chExt cx="2110128" cy="290853"/>
              </a:xfrm>
            </p:grpSpPr>
            <p:sp>
              <p:nvSpPr>
                <p:cNvPr id="76" name="Rectangle 75"/>
                <p:cNvSpPr/>
                <p:nvPr/>
              </p:nvSpPr>
              <p:spPr>
                <a:xfrm>
                  <a:off x="5230893" y="616062"/>
                  <a:ext cx="931026" cy="232756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7" name="Rectangle 76"/>
                <p:cNvSpPr/>
                <p:nvPr/>
              </p:nvSpPr>
              <p:spPr>
                <a:xfrm>
                  <a:off x="6161919" y="616062"/>
                  <a:ext cx="731520" cy="232756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>
                  <a:off x="6893439" y="616062"/>
                  <a:ext cx="365760" cy="232756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5354967" y="593941"/>
                  <a:ext cx="6735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ZmUbi1</a:t>
                  </a: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6933537" y="593941"/>
                  <a:ext cx="4074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nos</a:t>
                  </a:r>
                  <a:endParaRPr lang="en-US" sz="1200" dirty="0"/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6271893" y="580087"/>
                  <a:ext cx="42672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ZFN</a:t>
                  </a:r>
                </a:p>
              </p:txBody>
            </p:sp>
          </p:grpSp>
          <p:cxnSp>
            <p:nvCxnSpPr>
              <p:cNvPr id="72" name="Straight Arrow Connector 71"/>
              <p:cNvCxnSpPr/>
              <p:nvPr/>
            </p:nvCxnSpPr>
            <p:spPr>
              <a:xfrm flipH="1">
                <a:off x="6341538" y="935135"/>
                <a:ext cx="18288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72"/>
              <p:cNvCxnSpPr/>
              <p:nvPr/>
            </p:nvCxnSpPr>
            <p:spPr>
              <a:xfrm>
                <a:off x="5659088" y="934799"/>
                <a:ext cx="18288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 flipV="1">
                <a:off x="5800405" y="928255"/>
                <a:ext cx="517268" cy="9776"/>
              </a:xfrm>
              <a:prstGeom prst="line">
                <a:avLst/>
              </a:prstGeom>
              <a:ln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CFF628F3-1A96-47EF-B2B2-5605F8C394F0}"/>
                  </a:ext>
                </a:extLst>
              </p:cNvPr>
              <p:cNvSpPr txBox="1"/>
              <p:nvPr/>
            </p:nvSpPr>
            <p:spPr>
              <a:xfrm>
                <a:off x="5912699" y="934623"/>
                <a:ext cx="6127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 kb</a:t>
                </a:r>
              </a:p>
            </p:txBody>
          </p:sp>
        </p:grpSp>
        <p:cxnSp>
          <p:nvCxnSpPr>
            <p:cNvPr id="82" name="Straight Arrow Connector 81"/>
            <p:cNvCxnSpPr/>
            <p:nvPr/>
          </p:nvCxnSpPr>
          <p:spPr>
            <a:xfrm>
              <a:off x="2888177" y="979358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/>
            <p:nvPr/>
          </p:nvCxnSpPr>
          <p:spPr>
            <a:xfrm flipH="1">
              <a:off x="3238116" y="979692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3050818" y="978162"/>
              <a:ext cx="274320" cy="10622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FF628F3-1A96-47EF-B2B2-5605F8C394F0}"/>
                </a:ext>
              </a:extLst>
            </p:cNvPr>
            <p:cNvSpPr txBox="1"/>
            <p:nvPr/>
          </p:nvSpPr>
          <p:spPr>
            <a:xfrm>
              <a:off x="2961679" y="702092"/>
              <a:ext cx="765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0.09 kb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303A8DF2-F465-4D5F-A62F-218242864605}"/>
              </a:ext>
            </a:extLst>
          </p:cNvPr>
          <p:cNvSpPr txBox="1"/>
          <p:nvPr/>
        </p:nvSpPr>
        <p:spPr>
          <a:xfrm rot="16200000">
            <a:off x="3806872" y="4180584"/>
            <a:ext cx="1313479" cy="296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WT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F1BE75C9-EBCB-45F5-925B-929BB47FA289}"/>
              </a:ext>
            </a:extLst>
          </p:cNvPr>
          <p:cNvSpPr txBox="1"/>
          <p:nvPr/>
        </p:nvSpPr>
        <p:spPr>
          <a:xfrm>
            <a:off x="4114800" y="877901"/>
            <a:ext cx="676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(a)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26553A9-1690-49C0-8D5A-2280D65FE342}"/>
              </a:ext>
            </a:extLst>
          </p:cNvPr>
          <p:cNvSpPr txBox="1"/>
          <p:nvPr/>
        </p:nvSpPr>
        <p:spPr>
          <a:xfrm>
            <a:off x="365760" y="2187090"/>
            <a:ext cx="676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(b)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F89B107-D6FC-4080-BAE5-A0E5714DF37D}"/>
              </a:ext>
            </a:extLst>
          </p:cNvPr>
          <p:cNvSpPr txBox="1"/>
          <p:nvPr/>
        </p:nvSpPr>
        <p:spPr>
          <a:xfrm>
            <a:off x="365760" y="4530240"/>
            <a:ext cx="676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(c)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F89B107-D6FC-4080-BAE5-A0E5714DF37D}"/>
              </a:ext>
            </a:extLst>
          </p:cNvPr>
          <p:cNvSpPr txBox="1"/>
          <p:nvPr/>
        </p:nvSpPr>
        <p:spPr>
          <a:xfrm>
            <a:off x="6964554" y="2279379"/>
            <a:ext cx="676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(d)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F89B107-D6FC-4080-BAE5-A0E5714DF37D}"/>
              </a:ext>
            </a:extLst>
          </p:cNvPr>
          <p:cNvSpPr txBox="1"/>
          <p:nvPr/>
        </p:nvSpPr>
        <p:spPr>
          <a:xfrm>
            <a:off x="6964554" y="4421965"/>
            <a:ext cx="676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(e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F01A8D8-B007-44B6-B423-4986C33A5456}"/>
              </a:ext>
            </a:extLst>
          </p:cNvPr>
          <p:cNvGrpSpPr/>
          <p:nvPr/>
        </p:nvGrpSpPr>
        <p:grpSpPr>
          <a:xfrm>
            <a:off x="1267490" y="1856935"/>
            <a:ext cx="3880144" cy="1890583"/>
            <a:chOff x="1267490" y="1828799"/>
            <a:chExt cx="3880144" cy="1890583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1F789A6-F65C-45B4-B898-EDC0FD9C16E2}"/>
                </a:ext>
              </a:extLst>
            </p:cNvPr>
            <p:cNvSpPr txBox="1"/>
            <p:nvPr/>
          </p:nvSpPr>
          <p:spPr>
            <a:xfrm rot="16200000">
              <a:off x="1189438" y="2416787"/>
              <a:ext cx="452905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5592590-70D3-4828-86E9-755E5DC64543}"/>
                </a:ext>
              </a:extLst>
            </p:cNvPr>
            <p:cNvSpPr txBox="1"/>
            <p:nvPr/>
          </p:nvSpPr>
          <p:spPr>
            <a:xfrm rot="16200000">
              <a:off x="1363825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-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1004B69-2006-4477-9E84-DD560A920C8D}"/>
                </a:ext>
              </a:extLst>
            </p:cNvPr>
            <p:cNvSpPr txBox="1"/>
            <p:nvPr/>
          </p:nvSpPr>
          <p:spPr>
            <a:xfrm rot="16200000">
              <a:off x="1521562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-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0DA454B1-7846-4B2B-975E-05020B12B807}"/>
                </a:ext>
              </a:extLst>
            </p:cNvPr>
            <p:cNvSpPr txBox="1"/>
            <p:nvPr/>
          </p:nvSpPr>
          <p:spPr>
            <a:xfrm rot="16200000">
              <a:off x="1709140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00C98DB-6803-4AE1-B835-04AFE82AFCB6}"/>
                </a:ext>
              </a:extLst>
            </p:cNvPr>
            <p:cNvSpPr txBox="1"/>
            <p:nvPr/>
          </p:nvSpPr>
          <p:spPr>
            <a:xfrm rot="16200000">
              <a:off x="1914577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9348F1C-A23A-4403-95A5-119C42AF8DDD}"/>
                </a:ext>
              </a:extLst>
            </p:cNvPr>
            <p:cNvSpPr txBox="1"/>
            <p:nvPr/>
          </p:nvSpPr>
          <p:spPr>
            <a:xfrm rot="16200000">
              <a:off x="2122314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DC8E881-C2C4-4BC4-BC17-7AAB62904639}"/>
                </a:ext>
              </a:extLst>
            </p:cNvPr>
            <p:cNvSpPr txBox="1"/>
            <p:nvPr/>
          </p:nvSpPr>
          <p:spPr>
            <a:xfrm rot="16200000">
              <a:off x="2362070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FD9CE05-61C0-4E67-A901-D1656241FA52}"/>
                </a:ext>
              </a:extLst>
            </p:cNvPr>
            <p:cNvSpPr txBox="1"/>
            <p:nvPr/>
          </p:nvSpPr>
          <p:spPr>
            <a:xfrm rot="16200000">
              <a:off x="2572174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7-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485D2B3-9CC5-4361-A918-FB38DD04105A}"/>
                </a:ext>
              </a:extLst>
            </p:cNvPr>
            <p:cNvSpPr txBox="1"/>
            <p:nvPr/>
          </p:nvSpPr>
          <p:spPr>
            <a:xfrm rot="16200000">
              <a:off x="2783174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7-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8D45EC6-BD85-49C8-AE76-27D784A229C7}"/>
                </a:ext>
              </a:extLst>
            </p:cNvPr>
            <p:cNvSpPr txBox="1"/>
            <p:nvPr/>
          </p:nvSpPr>
          <p:spPr>
            <a:xfrm rot="16200000">
              <a:off x="3020655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AB3DED6-6DBE-451E-8343-83B708C00D7E}"/>
                </a:ext>
              </a:extLst>
            </p:cNvPr>
            <p:cNvSpPr txBox="1"/>
            <p:nvPr/>
          </p:nvSpPr>
          <p:spPr>
            <a:xfrm rot="16200000">
              <a:off x="3285527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9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33EB9B1-3AAE-49B7-88B8-993B077665B5}"/>
                </a:ext>
              </a:extLst>
            </p:cNvPr>
            <p:cNvSpPr txBox="1"/>
            <p:nvPr/>
          </p:nvSpPr>
          <p:spPr>
            <a:xfrm rot="16200000">
              <a:off x="3508052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6723794-2E63-4BE5-9BD8-46C920AA9327}"/>
                </a:ext>
              </a:extLst>
            </p:cNvPr>
            <p:cNvSpPr txBox="1"/>
            <p:nvPr/>
          </p:nvSpPr>
          <p:spPr>
            <a:xfrm rot="16200000">
              <a:off x="3753210" y="2383572"/>
              <a:ext cx="51933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0681FB3-7E4D-47B5-9053-2543DC8CE0ED}"/>
                </a:ext>
              </a:extLst>
            </p:cNvPr>
            <p:cNvSpPr txBox="1"/>
            <p:nvPr/>
          </p:nvSpPr>
          <p:spPr>
            <a:xfrm rot="16200000">
              <a:off x="3775006" y="2161819"/>
              <a:ext cx="96284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+ (</a:t>
              </a:r>
              <a:r>
                <a:rPr lang="en-US" sz="1200" dirty="0" err="1"/>
                <a:t>pUbi:ZFN</a:t>
              </a:r>
              <a:r>
                <a:rPr lang="en-US" sz="1200" dirty="0"/>
                <a:t>)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19585FD-7796-42D6-8826-4FE3A2C5AE5E}"/>
                </a:ext>
              </a:extLst>
            </p:cNvPr>
            <p:cNvSpPr txBox="1"/>
            <p:nvPr/>
          </p:nvSpPr>
          <p:spPr>
            <a:xfrm rot="16200000">
              <a:off x="4237738" y="2334814"/>
              <a:ext cx="61685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959E609-013E-478E-AEFC-5C8C2E871DCD}"/>
                </a:ext>
              </a:extLst>
            </p:cNvPr>
            <p:cNvSpPr txBox="1"/>
            <p:nvPr/>
          </p:nvSpPr>
          <p:spPr>
            <a:xfrm rot="16200000">
              <a:off x="4577717" y="2359527"/>
              <a:ext cx="567424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NTC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D7615E2E-D79F-4064-BD3C-56F9BB3F5DE0}"/>
                </a:ext>
              </a:extLst>
            </p:cNvPr>
            <p:cNvCxnSpPr>
              <a:cxnSpLocks/>
            </p:cNvCxnSpPr>
            <p:nvPr/>
          </p:nvCxnSpPr>
          <p:spPr>
            <a:xfrm>
              <a:off x="1395307" y="2374767"/>
              <a:ext cx="26315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FF628F3-1A96-47EF-B2B2-5605F8C394F0}"/>
                </a:ext>
              </a:extLst>
            </p:cNvPr>
            <p:cNvSpPr txBox="1"/>
            <p:nvPr/>
          </p:nvSpPr>
          <p:spPr>
            <a:xfrm>
              <a:off x="2696678" y="2113476"/>
              <a:ext cx="3893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0</a:t>
              </a:r>
            </a:p>
          </p:txBody>
        </p:sp>
        <p:pic>
          <p:nvPicPr>
            <p:cNvPr id="105" name="Picture 104"/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308005" y="2755556"/>
              <a:ext cx="3839629" cy="963826"/>
            </a:xfrm>
            <a:prstGeom prst="rect">
              <a:avLst/>
            </a:prstGeom>
          </p:spPr>
        </p:pic>
        <p:cxnSp>
          <p:nvCxnSpPr>
            <p:cNvPr id="133" name="Straight Arrow Connector 132"/>
            <p:cNvCxnSpPr/>
            <p:nvPr/>
          </p:nvCxnSpPr>
          <p:spPr>
            <a:xfrm flipV="1">
              <a:off x="3991232" y="3499250"/>
              <a:ext cx="229813" cy="2077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4B182B3-7D74-48E0-9CBC-5852D4CDDB91}"/>
              </a:ext>
            </a:extLst>
          </p:cNvPr>
          <p:cNvGrpSpPr/>
          <p:nvPr/>
        </p:nvGrpSpPr>
        <p:grpSpPr>
          <a:xfrm>
            <a:off x="1308005" y="3700380"/>
            <a:ext cx="3818236" cy="2271361"/>
            <a:chOff x="1267490" y="3672245"/>
            <a:chExt cx="3818236" cy="2271361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A49AE13-B65F-4506-B111-FCB1BFA75772}"/>
                </a:ext>
              </a:extLst>
            </p:cNvPr>
            <p:cNvSpPr txBox="1"/>
            <p:nvPr/>
          </p:nvSpPr>
          <p:spPr>
            <a:xfrm rot="16200000">
              <a:off x="1207125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-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7B254F1-EFC9-4499-90E8-FD984ABA5B67}"/>
                </a:ext>
              </a:extLst>
            </p:cNvPr>
            <p:cNvSpPr txBox="1"/>
            <p:nvPr/>
          </p:nvSpPr>
          <p:spPr>
            <a:xfrm rot="16200000">
              <a:off x="2485749" y="4536302"/>
              <a:ext cx="602042" cy="29680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.1.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CBB947A-64D3-462C-A4BA-3CC5B66208BF}"/>
                </a:ext>
              </a:extLst>
            </p:cNvPr>
            <p:cNvSpPr txBox="1"/>
            <p:nvPr/>
          </p:nvSpPr>
          <p:spPr>
            <a:xfrm rot="16200000">
              <a:off x="2750121" y="4536302"/>
              <a:ext cx="602042" cy="29680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.1.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B8081CB-3489-4D47-A382-DF64BF21612E}"/>
                </a:ext>
              </a:extLst>
            </p:cNvPr>
            <p:cNvSpPr txBox="1"/>
            <p:nvPr/>
          </p:nvSpPr>
          <p:spPr>
            <a:xfrm rot="16200000">
              <a:off x="1581246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-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002ABD1-B652-47AF-82AA-FFF0BFFAC65A}"/>
                </a:ext>
              </a:extLst>
            </p:cNvPr>
            <p:cNvSpPr txBox="1"/>
            <p:nvPr/>
          </p:nvSpPr>
          <p:spPr>
            <a:xfrm rot="16200000">
              <a:off x="1892392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-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C678649-3678-4513-8850-2B6EF4E73228}"/>
                </a:ext>
              </a:extLst>
            </p:cNvPr>
            <p:cNvSpPr txBox="1"/>
            <p:nvPr/>
          </p:nvSpPr>
          <p:spPr>
            <a:xfrm rot="16200000">
              <a:off x="2182632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-4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55E7365-D984-437F-931D-A40AC4AC4763}"/>
                </a:ext>
              </a:extLst>
            </p:cNvPr>
            <p:cNvSpPr txBox="1"/>
            <p:nvPr/>
          </p:nvSpPr>
          <p:spPr>
            <a:xfrm rot="16200000">
              <a:off x="3172126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2C6C41B-5EA7-4C20-ABCC-B1754C92DE5E}"/>
                </a:ext>
              </a:extLst>
            </p:cNvPr>
            <p:cNvSpPr txBox="1"/>
            <p:nvPr/>
          </p:nvSpPr>
          <p:spPr>
            <a:xfrm rot="16200000">
              <a:off x="3552258" y="4607308"/>
              <a:ext cx="460031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6E72A6E-40C7-447D-A4F7-E52C2820AB07}"/>
                </a:ext>
              </a:extLst>
            </p:cNvPr>
            <p:cNvSpPr txBox="1"/>
            <p:nvPr/>
          </p:nvSpPr>
          <p:spPr>
            <a:xfrm rot="16200000">
              <a:off x="3450877" y="4180584"/>
              <a:ext cx="1313479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+ (</a:t>
              </a:r>
              <a:r>
                <a:rPr lang="en-US" sz="1200" dirty="0" err="1"/>
                <a:t>pUbi:ZFN</a:t>
              </a:r>
              <a:r>
                <a:rPr lang="en-US" sz="1200" dirty="0"/>
                <a:t>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61BE2AC-2DC4-474A-952B-7052DC8C0449}"/>
                </a:ext>
              </a:extLst>
            </p:cNvPr>
            <p:cNvSpPr txBox="1"/>
            <p:nvPr/>
          </p:nvSpPr>
          <p:spPr>
            <a:xfrm rot="16200000">
              <a:off x="4132716" y="4180584"/>
              <a:ext cx="1313479" cy="296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NTC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DA2D94B8-51C6-4185-AF46-F10E776C72A8}"/>
                </a:ext>
              </a:extLst>
            </p:cNvPr>
            <p:cNvCxnSpPr>
              <a:cxnSpLocks/>
            </p:cNvCxnSpPr>
            <p:nvPr/>
          </p:nvCxnSpPr>
          <p:spPr>
            <a:xfrm>
              <a:off x="1369663" y="4536081"/>
              <a:ext cx="248625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8E9B74E-6C98-4FF6-9E29-D2DD3F975072}"/>
                </a:ext>
              </a:extLst>
            </p:cNvPr>
            <p:cNvSpPr txBox="1"/>
            <p:nvPr/>
          </p:nvSpPr>
          <p:spPr>
            <a:xfrm>
              <a:off x="2647753" y="4237997"/>
              <a:ext cx="4661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1</a:t>
              </a:r>
            </a:p>
          </p:txBody>
        </p:sp>
        <p:pic>
          <p:nvPicPr>
            <p:cNvPr id="106" name="Picture 10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67490" y="4996243"/>
              <a:ext cx="2704566" cy="947363"/>
            </a:xfrm>
            <a:prstGeom prst="rect">
              <a:avLst/>
            </a:prstGeom>
          </p:spPr>
        </p:pic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61850" y="4996244"/>
              <a:ext cx="1123876" cy="947362"/>
            </a:xfrm>
            <a:prstGeom prst="rect">
              <a:avLst/>
            </a:prstGeom>
          </p:spPr>
        </p:pic>
        <p:cxnSp>
          <p:nvCxnSpPr>
            <p:cNvPr id="138" name="Straight Arrow Connector 137"/>
            <p:cNvCxnSpPr/>
            <p:nvPr/>
          </p:nvCxnSpPr>
          <p:spPr>
            <a:xfrm flipV="1">
              <a:off x="3822356" y="5455737"/>
              <a:ext cx="229813" cy="2077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8B4B9AF4-AD5C-44B1-8567-04E53E3FD9E8}"/>
              </a:ext>
            </a:extLst>
          </p:cNvPr>
          <p:cNvGrpSpPr/>
          <p:nvPr/>
        </p:nvGrpSpPr>
        <p:grpSpPr>
          <a:xfrm>
            <a:off x="8195948" y="1706534"/>
            <a:ext cx="2228443" cy="1929775"/>
            <a:chOff x="8195948" y="1678398"/>
            <a:chExt cx="2228443" cy="1929775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17FB017C-6145-48B9-84EE-2B79013A0294}"/>
                </a:ext>
              </a:extLst>
            </p:cNvPr>
            <p:cNvSpPr txBox="1"/>
            <p:nvPr/>
          </p:nvSpPr>
          <p:spPr>
            <a:xfrm rot="16200000">
              <a:off x="8162923" y="2324132"/>
              <a:ext cx="49078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/>
                <a:t>3-3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5348A06-9B39-4ED6-82E1-67B00011A3FB}"/>
                </a:ext>
              </a:extLst>
            </p:cNvPr>
            <p:cNvSpPr txBox="1"/>
            <p:nvPr/>
          </p:nvSpPr>
          <p:spPr>
            <a:xfrm rot="16200000">
              <a:off x="8483008" y="2310069"/>
              <a:ext cx="490792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3-4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E374EB8-6EB3-42EC-8902-8A4DF814B59C}"/>
                </a:ext>
              </a:extLst>
            </p:cNvPr>
            <p:cNvSpPr txBox="1"/>
            <p:nvPr/>
          </p:nvSpPr>
          <p:spPr>
            <a:xfrm rot="16200000">
              <a:off x="8727412" y="2254757"/>
              <a:ext cx="601416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3-5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7DA64EA-F6A6-40E6-8CD1-0F28CE5BACD0}"/>
                </a:ext>
              </a:extLst>
            </p:cNvPr>
            <p:cNvSpPr txBox="1"/>
            <p:nvPr/>
          </p:nvSpPr>
          <p:spPr>
            <a:xfrm rot="16200000">
              <a:off x="9118542" y="2305696"/>
              <a:ext cx="499538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3-6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FD8135D3-FCEA-4C74-A9CA-FB55524C3459}"/>
                </a:ext>
              </a:extLst>
            </p:cNvPr>
            <p:cNvSpPr txBox="1"/>
            <p:nvPr/>
          </p:nvSpPr>
          <p:spPr>
            <a:xfrm rot="16200000">
              <a:off x="9137527" y="2047682"/>
              <a:ext cx="1015567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+ (</a:t>
              </a:r>
              <a:r>
                <a:rPr lang="en-US" sz="1200" dirty="0" err="1"/>
                <a:t>pUbi:ZFN</a:t>
              </a:r>
              <a:r>
                <a:rPr lang="en-US" sz="1200" dirty="0"/>
                <a:t>)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761902CD-836D-4CEE-9295-A414E1D33474}"/>
                </a:ext>
              </a:extLst>
            </p:cNvPr>
            <p:cNvSpPr txBox="1"/>
            <p:nvPr/>
          </p:nvSpPr>
          <p:spPr>
            <a:xfrm rot="16200000">
              <a:off x="9740029" y="2329894"/>
              <a:ext cx="451143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2575786F-5A0C-4E4B-BA91-3CFE350A11C2}"/>
                </a:ext>
              </a:extLst>
            </p:cNvPr>
            <p:cNvSpPr txBox="1"/>
            <p:nvPr/>
          </p:nvSpPr>
          <p:spPr>
            <a:xfrm rot="16200000">
              <a:off x="10049953" y="2319526"/>
              <a:ext cx="471878" cy="276999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r>
                <a:rPr lang="en-US" sz="1200" dirty="0"/>
                <a:t>NTC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BDE0CD57-9FF7-4325-98B3-B57C282549DF}"/>
                </a:ext>
              </a:extLst>
            </p:cNvPr>
            <p:cNvCxnSpPr>
              <a:cxnSpLocks/>
            </p:cNvCxnSpPr>
            <p:nvPr/>
          </p:nvCxnSpPr>
          <p:spPr>
            <a:xfrm>
              <a:off x="8195948" y="2237366"/>
              <a:ext cx="128016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8E06F5D-0615-46D5-8EC4-5EE603063FF8}"/>
                </a:ext>
              </a:extLst>
            </p:cNvPr>
            <p:cNvSpPr txBox="1"/>
            <p:nvPr/>
          </p:nvSpPr>
          <p:spPr>
            <a:xfrm>
              <a:off x="8698601" y="1986665"/>
              <a:ext cx="444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1</a:t>
              </a:r>
            </a:p>
          </p:txBody>
        </p:sp>
        <p:pic>
          <p:nvPicPr>
            <p:cNvPr id="109" name="Picture 108"/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12" t="2703" r="29640" b="21579"/>
            <a:stretch/>
          </p:blipFill>
          <p:spPr>
            <a:xfrm>
              <a:off x="8245475" y="2673176"/>
              <a:ext cx="2178685" cy="934997"/>
            </a:xfrm>
            <a:prstGeom prst="rect">
              <a:avLst/>
            </a:prstGeom>
          </p:spPr>
        </p:pic>
        <p:cxnSp>
          <p:nvCxnSpPr>
            <p:cNvPr id="139" name="Straight Arrow Connector 138"/>
            <p:cNvCxnSpPr/>
            <p:nvPr/>
          </p:nvCxnSpPr>
          <p:spPr>
            <a:xfrm flipV="1">
              <a:off x="9276998" y="3199607"/>
              <a:ext cx="229813" cy="2077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4" name="TextBox 93">
            <a:extLst>
              <a:ext uri="{FF2B5EF4-FFF2-40B4-BE49-F238E27FC236}">
                <a16:creationId xmlns:a16="http://schemas.microsoft.com/office/drawing/2014/main" id="{83653FA0-7CF0-41C4-A8BA-69D823490C74}"/>
              </a:ext>
            </a:extLst>
          </p:cNvPr>
          <p:cNvSpPr txBox="1"/>
          <p:nvPr/>
        </p:nvSpPr>
        <p:spPr>
          <a:xfrm>
            <a:off x="5049030" y="3207110"/>
            <a:ext cx="656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1 kb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2E4B1DE-2F81-4144-9E0A-246A21787E3D}"/>
              </a:ext>
            </a:extLst>
          </p:cNvPr>
          <p:cNvSpPr txBox="1"/>
          <p:nvPr/>
        </p:nvSpPr>
        <p:spPr>
          <a:xfrm>
            <a:off x="5049030" y="5133717"/>
            <a:ext cx="656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1 kb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739A418-5E95-49D0-906E-AF98ACC02062}"/>
              </a:ext>
            </a:extLst>
          </p:cNvPr>
          <p:cNvSpPr txBox="1"/>
          <p:nvPr/>
        </p:nvSpPr>
        <p:spPr>
          <a:xfrm>
            <a:off x="10424160" y="2983669"/>
            <a:ext cx="656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 kb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5A5F66A-5E99-4904-B868-4E685BE08F30}"/>
              </a:ext>
            </a:extLst>
          </p:cNvPr>
          <p:cNvGrpSpPr/>
          <p:nvPr/>
        </p:nvGrpSpPr>
        <p:grpSpPr>
          <a:xfrm>
            <a:off x="8225484" y="3848626"/>
            <a:ext cx="2855274" cy="2011773"/>
            <a:chOff x="8225484" y="3848626"/>
            <a:chExt cx="2855274" cy="2011773"/>
          </a:xfrm>
        </p:grpSpPr>
        <p:pic>
          <p:nvPicPr>
            <p:cNvPr id="115" name="Content Placeholder 3"/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81" t="56335" r="20150" b="29561"/>
            <a:stretch/>
          </p:blipFill>
          <p:spPr>
            <a:xfrm>
              <a:off x="8245475" y="4933769"/>
              <a:ext cx="2178685" cy="926630"/>
            </a:xfrm>
            <a:prstGeom prst="rect">
              <a:avLst/>
            </a:prstGeom>
          </p:spPr>
        </p:pic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7FB017C-6145-48B9-84EE-2B79013A0294}"/>
                </a:ext>
              </a:extLst>
            </p:cNvPr>
            <p:cNvSpPr txBox="1"/>
            <p:nvPr/>
          </p:nvSpPr>
          <p:spPr>
            <a:xfrm rot="16200000">
              <a:off x="8596284" y="4534575"/>
              <a:ext cx="601217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3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95348A06-9B39-4ED6-82E1-67B00011A3FB}"/>
                </a:ext>
              </a:extLst>
            </p:cNvPr>
            <p:cNvSpPr txBox="1"/>
            <p:nvPr/>
          </p:nvSpPr>
          <p:spPr>
            <a:xfrm rot="16200000">
              <a:off x="8837609" y="4534575"/>
              <a:ext cx="601218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4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D8135D3-FCEA-4C74-A9CA-FB55524C3459}"/>
                </a:ext>
              </a:extLst>
            </p:cNvPr>
            <p:cNvSpPr txBox="1"/>
            <p:nvPr/>
          </p:nvSpPr>
          <p:spPr>
            <a:xfrm rot="16200000">
              <a:off x="8862727" y="4270961"/>
              <a:ext cx="1121667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HS: ZFN #7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761902CD-836D-4CEE-9295-A414E1D33474}"/>
                </a:ext>
              </a:extLst>
            </p:cNvPr>
            <p:cNvSpPr txBox="1"/>
            <p:nvPr/>
          </p:nvSpPr>
          <p:spPr>
            <a:xfrm rot="16200000">
              <a:off x="9200566" y="4283002"/>
              <a:ext cx="109758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T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2575786F-5A0C-4E4B-BA91-3CFE350A11C2}"/>
                </a:ext>
              </a:extLst>
            </p:cNvPr>
            <p:cNvSpPr txBox="1"/>
            <p:nvPr/>
          </p:nvSpPr>
          <p:spPr>
            <a:xfrm rot="16200000">
              <a:off x="9477565" y="4283002"/>
              <a:ext cx="109758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NTC</a:t>
              </a:r>
            </a:p>
          </p:txBody>
        </p: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BDE0CD57-9FF7-4325-98B3-B57C282549DF}"/>
                </a:ext>
              </a:extLst>
            </p:cNvPr>
            <p:cNvCxnSpPr>
              <a:cxnSpLocks/>
            </p:cNvCxnSpPr>
            <p:nvPr/>
          </p:nvCxnSpPr>
          <p:spPr>
            <a:xfrm>
              <a:off x="8225484" y="4562936"/>
              <a:ext cx="10058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68E06F5D-0615-46D5-8EC4-5EE603063FF8}"/>
                </a:ext>
              </a:extLst>
            </p:cNvPr>
            <p:cNvSpPr txBox="1"/>
            <p:nvPr/>
          </p:nvSpPr>
          <p:spPr>
            <a:xfrm>
              <a:off x="8600687" y="4250011"/>
              <a:ext cx="4282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T1</a:t>
              </a:r>
            </a:p>
          </p:txBody>
        </p:sp>
        <p:cxnSp>
          <p:nvCxnSpPr>
            <p:cNvPr id="140" name="Straight Arrow Connector 139"/>
            <p:cNvCxnSpPr/>
            <p:nvPr/>
          </p:nvCxnSpPr>
          <p:spPr>
            <a:xfrm flipV="1">
              <a:off x="9162091" y="5397084"/>
              <a:ext cx="229813" cy="2077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D433F07-4C94-4D19-BB64-C7E8028F402E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8198841" y="4603612"/>
              <a:ext cx="460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1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1F5D2320-C4BE-4B34-A3D2-EFCBF098260F}"/>
                </a:ext>
              </a:extLst>
            </p:cNvPr>
            <p:cNvSpPr txBox="1"/>
            <p:nvPr/>
          </p:nvSpPr>
          <p:spPr>
            <a:xfrm rot="16200000">
              <a:off x="8418441" y="4581885"/>
              <a:ext cx="5034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-2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12CFDBC-2E07-4E33-9970-17B1EBDDAF7C}"/>
                </a:ext>
              </a:extLst>
            </p:cNvPr>
            <p:cNvSpPr txBox="1"/>
            <p:nvPr/>
          </p:nvSpPr>
          <p:spPr>
            <a:xfrm>
              <a:off x="10424160" y="5170979"/>
              <a:ext cx="6565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0.09 k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02867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</TotalTime>
  <Words>94</Words>
  <Application>Microsoft Office PowerPoint</Application>
  <PresentationFormat>Widescreen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van Pathak</dc:creator>
  <cp:lastModifiedBy>Bhuvan Pathak</cp:lastModifiedBy>
  <cp:revision>25</cp:revision>
  <dcterms:created xsi:type="dcterms:W3CDTF">2019-04-15T02:45:28Z</dcterms:created>
  <dcterms:modified xsi:type="dcterms:W3CDTF">2019-04-17T04:55:57Z</dcterms:modified>
</cp:coreProperties>
</file>